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1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6586" autoAdjust="0"/>
  </p:normalViewPr>
  <p:slideViewPr>
    <p:cSldViewPr snapToGrid="0">
      <p:cViewPr varScale="1">
        <p:scale>
          <a:sx n="79" d="100"/>
          <a:sy n="79" d="100"/>
        </p:scale>
        <p:origin x="3048" y="9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72" d="100"/>
        <a:sy n="17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55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31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656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853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9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84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73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762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109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097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484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543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2463506" y="255448"/>
            <a:ext cx="1772188" cy="860426"/>
            <a:chOff x="2189735" y="70545"/>
            <a:chExt cx="1772188" cy="860426"/>
          </a:xfrm>
        </p:grpSpPr>
        <p:sp>
          <p:nvSpPr>
            <p:cNvPr id="13" name="Rectangle 12"/>
            <p:cNvSpPr/>
            <p:nvPr/>
          </p:nvSpPr>
          <p:spPr>
            <a:xfrm>
              <a:off x="2189735" y="306865"/>
              <a:ext cx="130073" cy="11836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189735" y="459265"/>
              <a:ext cx="130073" cy="11836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189735" y="611665"/>
              <a:ext cx="130073" cy="11836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2189735" y="764065"/>
              <a:ext cx="130073" cy="11836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115904" y="306865"/>
              <a:ext cx="130073" cy="11836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115904" y="459265"/>
              <a:ext cx="130073" cy="118368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3115904" y="611665"/>
              <a:ext cx="130073" cy="118368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3115904" y="764065"/>
              <a:ext cx="130073" cy="118368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254771" y="258327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FED</a:t>
              </a:r>
              <a:endParaRPr lang="en-GB" sz="8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254771" y="563127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FED</a:t>
              </a:r>
              <a:endParaRPr lang="en-GB" sz="8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254771" y="410727"/>
              <a:ext cx="6735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FASTED</a:t>
              </a:r>
              <a:endParaRPr lang="en-GB" sz="8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254771" y="715527"/>
              <a:ext cx="7809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FASTED</a:t>
              </a:r>
              <a:endParaRPr lang="en-GB" sz="8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180940" y="258327"/>
              <a:ext cx="5116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FED</a:t>
              </a:r>
              <a:endParaRPr lang="en-GB" sz="8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180940" y="563127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FED</a:t>
              </a:r>
              <a:endParaRPr lang="en-GB" sz="8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180940" y="410727"/>
              <a:ext cx="6735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FASTED</a:t>
              </a:r>
              <a:endParaRPr lang="en-GB" sz="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180940" y="715527"/>
              <a:ext cx="7809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FASTED</a:t>
              </a:r>
              <a:endParaRPr lang="en-GB" sz="800" b="1" dirty="0"/>
            </a:p>
          </p:txBody>
        </p:sp>
        <p:cxnSp>
          <p:nvCxnSpPr>
            <p:cNvPr id="29" name="Straight Connector 28"/>
            <p:cNvCxnSpPr/>
            <p:nvPr/>
          </p:nvCxnSpPr>
          <p:spPr>
            <a:xfrm>
              <a:off x="2189735" y="258327"/>
              <a:ext cx="722964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109331" y="259087"/>
              <a:ext cx="722964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2201872" y="70545"/>
              <a:ext cx="6799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CHOW DIET</a:t>
              </a:r>
              <a:endParaRPr lang="en-GB" sz="8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183715" y="70545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</p:grpSp>
      <p:sp>
        <p:nvSpPr>
          <p:cNvPr id="61" name="TextBox 60"/>
          <p:cNvSpPr txBox="1"/>
          <p:nvPr/>
        </p:nvSpPr>
        <p:spPr>
          <a:xfrm>
            <a:off x="5821746" y="9419573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</a:t>
            </a:r>
            <a:r>
              <a:rPr lang="en-GB" dirty="0" smtClean="0"/>
              <a:t>FIG 1</a:t>
            </a:r>
            <a:endParaRPr lang="en-GB" dirty="0"/>
          </a:p>
        </p:txBody>
      </p:sp>
      <p:grpSp>
        <p:nvGrpSpPr>
          <p:cNvPr id="62" name="Group 61"/>
          <p:cNvGrpSpPr/>
          <p:nvPr/>
        </p:nvGrpSpPr>
        <p:grpSpPr>
          <a:xfrm>
            <a:off x="2140947" y="9311851"/>
            <a:ext cx="2627526" cy="215444"/>
            <a:chOff x="3886725" y="413334"/>
            <a:chExt cx="2627526" cy="215444"/>
          </a:xfrm>
        </p:grpSpPr>
        <p:sp>
          <p:nvSpPr>
            <p:cNvPr id="63" name="Oval 62"/>
            <p:cNvSpPr/>
            <p:nvPr/>
          </p:nvSpPr>
          <p:spPr>
            <a:xfrm>
              <a:off x="3886725" y="485046"/>
              <a:ext cx="70339" cy="63304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4" name="Oval 63"/>
            <p:cNvSpPr/>
            <p:nvPr/>
          </p:nvSpPr>
          <p:spPr>
            <a:xfrm>
              <a:off x="4193833" y="485046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Oval 64"/>
            <p:cNvSpPr/>
            <p:nvPr/>
          </p:nvSpPr>
          <p:spPr>
            <a:xfrm>
              <a:off x="4458699" y="485046"/>
              <a:ext cx="70339" cy="63304"/>
            </a:xfrm>
            <a:prstGeom prst="ellipse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Oval 65"/>
            <p:cNvSpPr/>
            <p:nvPr/>
          </p:nvSpPr>
          <p:spPr>
            <a:xfrm>
              <a:off x="4737980" y="485046"/>
              <a:ext cx="70339" cy="6330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Oval 66"/>
            <p:cNvSpPr/>
            <p:nvPr/>
          </p:nvSpPr>
          <p:spPr>
            <a:xfrm>
              <a:off x="5131840" y="498095"/>
              <a:ext cx="70339" cy="6330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Oval 67"/>
            <p:cNvSpPr/>
            <p:nvPr/>
          </p:nvSpPr>
          <p:spPr>
            <a:xfrm>
              <a:off x="5534176" y="503461"/>
              <a:ext cx="70339" cy="63304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9" name="Oval 68"/>
            <p:cNvSpPr/>
            <p:nvPr/>
          </p:nvSpPr>
          <p:spPr>
            <a:xfrm>
              <a:off x="5928336" y="506972"/>
              <a:ext cx="70339" cy="63304"/>
            </a:xfrm>
            <a:prstGeom prst="ellipse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929765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</a:t>
              </a:r>
              <a:endParaRPr lang="en-GB" sz="800" b="1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238097" y="413334"/>
              <a:ext cx="2311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/>
                <a:t>F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508226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D</a:t>
              </a:r>
              <a:endParaRPr lang="en-GB" sz="8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790889" y="413334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F</a:t>
              </a:r>
              <a:endParaRPr lang="en-GB" sz="8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166100" y="413334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D</a:t>
              </a:r>
              <a:endParaRPr lang="en-GB" sz="800" b="1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970512" y="413334"/>
              <a:ext cx="54373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F x D</a:t>
              </a:r>
              <a:endParaRPr lang="en-GB" sz="800" b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579058" y="41333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F x D</a:t>
              </a:r>
              <a:endParaRPr lang="en-GB" sz="800" b="1" dirty="0"/>
            </a:p>
          </p:txBody>
        </p:sp>
      </p:grp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52443" t="14445" r="30126" b="41941"/>
          <a:stretch/>
        </p:blipFill>
        <p:spPr>
          <a:xfrm>
            <a:off x="271667" y="1121922"/>
            <a:ext cx="2543973" cy="1790334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3"/>
          <a:srcRect l="52444" t="16973" r="2044" b="38148"/>
          <a:stretch/>
        </p:blipFill>
        <p:spPr>
          <a:xfrm>
            <a:off x="30946" y="2912483"/>
            <a:ext cx="6591505" cy="1828113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4"/>
          <a:srcRect l="52622" t="22030" r="2755" b="34987"/>
          <a:stretch/>
        </p:blipFill>
        <p:spPr>
          <a:xfrm>
            <a:off x="202315" y="4716089"/>
            <a:ext cx="6480407" cy="1755648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 rotWithShape="1">
          <a:blip r:embed="rId2"/>
          <a:srcRect l="80383" t="14445" r="2882" b="41941"/>
          <a:stretch/>
        </p:blipFill>
        <p:spPr>
          <a:xfrm>
            <a:off x="4180044" y="1067336"/>
            <a:ext cx="2442407" cy="1790334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5"/>
          <a:srcRect l="52622" t="35303" r="29749" b="22978"/>
          <a:stretch/>
        </p:blipFill>
        <p:spPr>
          <a:xfrm>
            <a:off x="357011" y="6720812"/>
            <a:ext cx="2633186" cy="1752628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5"/>
          <a:srcRect l="81583" t="35303" r="1693" b="22978"/>
          <a:stretch/>
        </p:blipFill>
        <p:spPr>
          <a:xfrm>
            <a:off x="4136218" y="6720812"/>
            <a:ext cx="2473352" cy="1735297"/>
          </a:xfrm>
          <a:prstGeom prst="rect">
            <a:avLst/>
          </a:prstGeom>
        </p:spPr>
      </p:pic>
      <p:grpSp>
        <p:nvGrpSpPr>
          <p:cNvPr id="85" name="Group 84"/>
          <p:cNvGrpSpPr/>
          <p:nvPr/>
        </p:nvGrpSpPr>
        <p:grpSpPr>
          <a:xfrm>
            <a:off x="952094" y="1503747"/>
            <a:ext cx="70339" cy="169421"/>
            <a:chOff x="5909715" y="4888250"/>
            <a:chExt cx="70339" cy="169421"/>
          </a:xfrm>
        </p:grpSpPr>
        <p:sp>
          <p:nvSpPr>
            <p:cNvPr id="86" name="Oval 85"/>
            <p:cNvSpPr/>
            <p:nvPr/>
          </p:nvSpPr>
          <p:spPr>
            <a:xfrm>
              <a:off x="5909715" y="4888250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7" name="Oval 86"/>
            <p:cNvSpPr/>
            <p:nvPr/>
          </p:nvSpPr>
          <p:spPr>
            <a:xfrm>
              <a:off x="5909715" y="4994367"/>
              <a:ext cx="70339" cy="6330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88" name="Oval 87"/>
          <p:cNvSpPr/>
          <p:nvPr/>
        </p:nvSpPr>
        <p:spPr>
          <a:xfrm>
            <a:off x="4643939" y="1489765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" name="Oval 88"/>
          <p:cNvSpPr/>
          <p:nvPr/>
        </p:nvSpPr>
        <p:spPr>
          <a:xfrm>
            <a:off x="4643939" y="1628062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Oval 89"/>
          <p:cNvSpPr/>
          <p:nvPr/>
        </p:nvSpPr>
        <p:spPr>
          <a:xfrm>
            <a:off x="915095" y="3440560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Oval 90"/>
          <p:cNvSpPr/>
          <p:nvPr/>
        </p:nvSpPr>
        <p:spPr>
          <a:xfrm>
            <a:off x="4649634" y="3408908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TextBox 91"/>
          <p:cNvSpPr txBox="1"/>
          <p:nvPr/>
        </p:nvSpPr>
        <p:spPr>
          <a:xfrm>
            <a:off x="4482677" y="4406630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4987998" y="4403773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474422" y="4404689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5993119" y="4408058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  <p:sp>
        <p:nvSpPr>
          <p:cNvPr id="96" name="Oval 95"/>
          <p:cNvSpPr/>
          <p:nvPr/>
        </p:nvSpPr>
        <p:spPr>
          <a:xfrm>
            <a:off x="4691001" y="5069780"/>
            <a:ext cx="70339" cy="6330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Oval 96"/>
          <p:cNvSpPr/>
          <p:nvPr/>
        </p:nvSpPr>
        <p:spPr>
          <a:xfrm>
            <a:off x="987668" y="4999755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Oval 97"/>
          <p:cNvSpPr/>
          <p:nvPr/>
        </p:nvSpPr>
        <p:spPr>
          <a:xfrm>
            <a:off x="987863" y="5145020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Oval 98"/>
          <p:cNvSpPr/>
          <p:nvPr/>
        </p:nvSpPr>
        <p:spPr>
          <a:xfrm>
            <a:off x="4666800" y="7036412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Oval 99"/>
          <p:cNvSpPr/>
          <p:nvPr/>
        </p:nvSpPr>
        <p:spPr>
          <a:xfrm>
            <a:off x="4666800" y="7150019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Oval 100"/>
          <p:cNvSpPr/>
          <p:nvPr/>
        </p:nvSpPr>
        <p:spPr>
          <a:xfrm>
            <a:off x="4664879" y="7251645"/>
            <a:ext cx="70339" cy="63304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2" name="Oval 101"/>
          <p:cNvSpPr/>
          <p:nvPr/>
        </p:nvSpPr>
        <p:spPr>
          <a:xfrm>
            <a:off x="998415" y="7225207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Oval 102"/>
          <p:cNvSpPr/>
          <p:nvPr/>
        </p:nvSpPr>
        <p:spPr>
          <a:xfrm>
            <a:off x="998415" y="7105823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4" name="Oval 103"/>
          <p:cNvSpPr/>
          <p:nvPr/>
        </p:nvSpPr>
        <p:spPr>
          <a:xfrm>
            <a:off x="998415" y="7344591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5" name="Oval 104"/>
          <p:cNvSpPr/>
          <p:nvPr/>
        </p:nvSpPr>
        <p:spPr>
          <a:xfrm>
            <a:off x="998414" y="7456422"/>
            <a:ext cx="70339" cy="63304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6" name="TextBox 105"/>
          <p:cNvSpPr txBox="1"/>
          <p:nvPr/>
        </p:nvSpPr>
        <p:spPr>
          <a:xfrm>
            <a:off x="4700594" y="613282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5224254" y="6132825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 smtClean="0"/>
              <a:t>nd</a:t>
            </a:r>
            <a:endParaRPr lang="en-GB" sz="1000" b="1" dirty="0"/>
          </a:p>
        </p:txBody>
      </p:sp>
    </p:spTree>
    <p:extLst>
      <p:ext uri="{BB962C8B-B14F-4D97-AF65-F5344CB8AC3E}">
        <p14:creationId xmlns:p14="http://schemas.microsoft.com/office/powerpoint/2010/main" val="19335642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992</TotalTime>
  <Words>45</Words>
  <Application>Microsoft Office PowerPoint</Application>
  <PresentationFormat>A4 Paper (210x297 mm)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Rodriguez-Cuenca</dc:creator>
  <cp:lastModifiedBy>Sergio Rodriguez-Cuenca</cp:lastModifiedBy>
  <cp:revision>276</cp:revision>
  <cp:lastPrinted>2017-08-07T10:49:05Z</cp:lastPrinted>
  <dcterms:created xsi:type="dcterms:W3CDTF">2017-01-24T20:07:34Z</dcterms:created>
  <dcterms:modified xsi:type="dcterms:W3CDTF">2018-05-04T09:34:38Z</dcterms:modified>
</cp:coreProperties>
</file>